
<file path=[Content_Types].xml><?xml version="1.0" encoding="utf-8"?>
<Types xmlns="http://schemas.openxmlformats.org/package/2006/content-types">
  <Default Extension="(null)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840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2336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7" d="100"/>
          <a:sy n="97" d="100"/>
        </p:scale>
        <p:origin x="2480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CD8C42C-6AA5-814C-9A3D-FD9C1BA161B7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97FAAF-812B-194D-BAEF-D795ED07B256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96859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A97FAAF-812B-194D-BAEF-D795ED07B256}" type="slidenum">
              <a:rPr lang="pl-PL" smtClean="0"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441539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l-PL"/>
              <a:t>Kliknij, aby edytować styl wzorca podtytuł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07324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50996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618081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46542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743233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440516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1743189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156149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3322559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572134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pl-PL"/>
              <a:t>Kliknij ikonę, aby dodać obraz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l-PL"/>
              <a:t>Edytuj style wzorca tekstu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8134914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Edytuj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6268C-C932-6441-987B-31136268E3F2}" type="datetimeFigureOut">
              <a:rPr lang="pl-PL" smtClean="0"/>
              <a:t>25.07.2022</a:t>
            </a:fld>
            <a:endParaRPr lang="pl-P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DD8087-6D8E-804B-B065-DD01D041812C}" type="slidenum">
              <a:rPr lang="pl-PL" smtClean="0"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575877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(null)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Obraz 8">
            <a:extLst>
              <a:ext uri="{FF2B5EF4-FFF2-40B4-BE49-F238E27FC236}">
                <a16:creationId xmlns:a16="http://schemas.microsoft.com/office/drawing/2014/main" id="{BA1F19DF-C94E-EF4E-85C7-49D5B00FFA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585" b="21737"/>
          <a:stretch/>
        </p:blipFill>
        <p:spPr>
          <a:xfrm>
            <a:off x="1765946" y="590470"/>
            <a:ext cx="2878088" cy="1711296"/>
          </a:xfrm>
          <a:prstGeom prst="rect">
            <a:avLst/>
          </a:prstGeom>
        </p:spPr>
      </p:pic>
      <p:sp>
        <p:nvSpPr>
          <p:cNvPr id="12" name="pole tekstowe 11">
            <a:extLst>
              <a:ext uri="{FF2B5EF4-FFF2-40B4-BE49-F238E27FC236}">
                <a16:creationId xmlns:a16="http://schemas.microsoft.com/office/drawing/2014/main" id="{3669B220-6ED2-594F-93A4-039408F837E3}"/>
              </a:ext>
            </a:extLst>
          </p:cNvPr>
          <p:cNvSpPr txBox="1"/>
          <p:nvPr/>
        </p:nvSpPr>
        <p:spPr>
          <a:xfrm>
            <a:off x="1227531" y="109220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pole tekstowe 17">
            <a:extLst>
              <a:ext uri="{FF2B5EF4-FFF2-40B4-BE49-F238E27FC236}">
                <a16:creationId xmlns:a16="http://schemas.microsoft.com/office/drawing/2014/main" id="{C47A4E6E-346D-1045-85FA-7BEBED06E048}"/>
              </a:ext>
            </a:extLst>
          </p:cNvPr>
          <p:cNvSpPr txBox="1"/>
          <p:nvPr/>
        </p:nvSpPr>
        <p:spPr>
          <a:xfrm>
            <a:off x="788276" y="4646604"/>
            <a:ext cx="751489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pl-PL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. 1a-b.</a:t>
            </a:r>
          </a:p>
          <a:p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ltrasonographic presentation of multinodular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oiter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wo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diatric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atients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CER1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ut+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amined with ultrasound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ok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SD 500) before December 2009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CER1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le discovery,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who were genetically confirmed in 2010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pl-PL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1a -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 (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mple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yst); Fig. 1b -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I (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ixed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pl-PL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ystic</a:t>
            </a:r>
            <a:r>
              <a:rPr lang="pl-PL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olid).</a:t>
            </a:r>
          </a:p>
        </p:txBody>
      </p:sp>
      <p:pic>
        <p:nvPicPr>
          <p:cNvPr id="10" name="Obraz 9">
            <a:extLst>
              <a:ext uri="{FF2B5EF4-FFF2-40B4-BE49-F238E27FC236}">
                <a16:creationId xmlns:a16="http://schemas.microsoft.com/office/drawing/2014/main" id="{886919E2-6D01-B94C-8185-7CAA0CC6B20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9351" t="7752" b="31920"/>
          <a:stretch/>
        </p:blipFill>
        <p:spPr>
          <a:xfrm>
            <a:off x="1765946" y="2567008"/>
            <a:ext cx="2877090" cy="1710702"/>
          </a:xfrm>
          <a:prstGeom prst="rect">
            <a:avLst/>
          </a:prstGeom>
        </p:spPr>
      </p:pic>
      <p:sp>
        <p:nvSpPr>
          <p:cNvPr id="13" name="pole tekstowe 12">
            <a:extLst>
              <a:ext uri="{FF2B5EF4-FFF2-40B4-BE49-F238E27FC236}">
                <a16:creationId xmlns:a16="http://schemas.microsoft.com/office/drawing/2014/main" id="{C3ED7B4D-D016-D647-ACDD-C34F36AA0AD0}"/>
              </a:ext>
            </a:extLst>
          </p:cNvPr>
          <p:cNvSpPr txBox="1"/>
          <p:nvPr/>
        </p:nvSpPr>
        <p:spPr>
          <a:xfrm>
            <a:off x="1230109" y="308624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l-PL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20494839"/>
      </p:ext>
    </p:extLst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Motyw pakietu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yw pakietu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yw pakietu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Pakiet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8</TotalTime>
  <Words>66</Words>
  <Application>Microsoft Macintosh PowerPoint</Application>
  <PresentationFormat>Pokaz na ekranie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Używane czcionki</vt:lpstr>
      </vt:variant>
      <vt:variant>
        <vt:i4>4</vt:i4>
      </vt:variant>
      <vt:variant>
        <vt:lpstr>Motyw</vt:lpstr>
      </vt:variant>
      <vt:variant>
        <vt:i4>1</vt:i4>
      </vt:variant>
      <vt:variant>
        <vt:lpstr>Tytuły slajdów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Motyw pakietu Office</vt:lpstr>
      <vt:lpstr>Prezentacja programu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ja programu PowerPoint</dc:title>
  <dc:creator>Marek Niedziela</dc:creator>
  <cp:lastModifiedBy>Marek Niedziela</cp:lastModifiedBy>
  <cp:revision>34</cp:revision>
  <cp:lastPrinted>2018-07-27T01:43:47Z</cp:lastPrinted>
  <dcterms:created xsi:type="dcterms:W3CDTF">2018-07-27T01:28:02Z</dcterms:created>
  <dcterms:modified xsi:type="dcterms:W3CDTF">2022-07-25T20:09:09Z</dcterms:modified>
</cp:coreProperties>
</file>